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69DE6-7FCF-4605-B1E0-EFDBC56A39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F1001-0E36-4F8F-9887-B5456F1AD3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2F1A6-EE1A-4D8C-ABB8-F44B05A903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B2604-4C4F-4002-917F-D1038955A4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4A663-3B6B-4C5B-AE83-0E2C1FA608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33B7B-1D61-432B-B9E4-DC9DF6C1E6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AA610-8B71-45D0-A9B8-BD5B189DD3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ABFEF-8538-4165-B1B9-4561124935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12435-11A7-4DE7-901E-950CC63F37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BF7AE-4E58-482C-8A5C-C0AF53FC16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B6241-4EB2-4E2C-991A-C051406205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A0CED-4DE0-4D1D-A932-38E114FB1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16A81E-FF21-4E54-87EF-8948D3834FD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8"/>
          <p:cNvGrpSpPr/>
          <p:nvPr/>
        </p:nvGrpSpPr>
        <p:grpSpPr>
          <a:xfrm>
            <a:off x="539640" y="476280"/>
            <a:ext cx="7383600" cy="4525560"/>
            <a:chOff x="539640" y="476280"/>
            <a:chExt cx="7383600" cy="4525560"/>
          </a:xfrm>
        </p:grpSpPr>
        <p:pic>
          <p:nvPicPr>
            <p:cNvPr id="42" name="Picture 18" descr=""/>
            <p:cNvPicPr/>
            <p:nvPr/>
          </p:nvPicPr>
          <p:blipFill>
            <a:blip r:embed="rId1"/>
            <a:srcRect l="11321" t="5846" r="33113" b="15828"/>
            <a:stretch/>
          </p:blipFill>
          <p:spPr>
            <a:xfrm>
              <a:off x="1093320" y="540720"/>
              <a:ext cx="3414240" cy="4010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Group 17"/>
            <p:cNvGrpSpPr/>
            <p:nvPr/>
          </p:nvGrpSpPr>
          <p:grpSpPr>
            <a:xfrm>
              <a:off x="751680" y="476280"/>
              <a:ext cx="409680" cy="4157640"/>
              <a:chOff x="751680" y="476280"/>
              <a:chExt cx="409680" cy="4157640"/>
            </a:xfrm>
          </p:grpSpPr>
          <p:sp>
            <p:nvSpPr>
              <p:cNvPr id="44" name="TextBox 6"/>
              <p:cNvSpPr/>
              <p:nvPr/>
            </p:nvSpPr>
            <p:spPr>
              <a:xfrm>
                <a:off x="751680" y="435744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Box 7"/>
              <p:cNvSpPr/>
              <p:nvPr/>
            </p:nvSpPr>
            <p:spPr>
              <a:xfrm>
                <a:off x="751680" y="338724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Box 8"/>
              <p:cNvSpPr/>
              <p:nvPr/>
            </p:nvSpPr>
            <p:spPr>
              <a:xfrm>
                <a:off x="751680" y="241668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9"/>
              <p:cNvSpPr/>
              <p:nvPr/>
            </p:nvSpPr>
            <p:spPr>
              <a:xfrm>
                <a:off x="751680" y="144648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10"/>
              <p:cNvSpPr/>
              <p:nvPr/>
            </p:nvSpPr>
            <p:spPr>
              <a:xfrm>
                <a:off x="751680" y="47628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" name="TextBox 19"/>
            <p:cNvSpPr/>
            <p:nvPr/>
          </p:nvSpPr>
          <p:spPr>
            <a:xfrm>
              <a:off x="2130480" y="4725360"/>
              <a:ext cx="150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Weeks starv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20"/>
            <p:cNvSpPr/>
            <p:nvPr/>
          </p:nvSpPr>
          <p:spPr>
            <a:xfrm rot="16200000">
              <a:off x="-356760" y="2665800"/>
              <a:ext cx="20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tal cell counts per m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21"/>
            <p:cNvSpPr/>
            <p:nvPr/>
          </p:nvSpPr>
          <p:spPr>
            <a:xfrm rot="16200000">
              <a:off x="3879360" y="2601000"/>
              <a:ext cx="20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Viable cell counts per m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2" descr=""/>
            <p:cNvPicPr/>
            <p:nvPr/>
          </p:nvPicPr>
          <p:blipFill>
            <a:blip r:embed="rId2"/>
            <a:srcRect l="0" t="92617" r="0" b="0"/>
            <a:stretch/>
          </p:blipFill>
          <p:spPr>
            <a:xfrm>
              <a:off x="1074240" y="4442040"/>
              <a:ext cx="3477240" cy="3398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3" name="Group 17"/>
            <p:cNvGrpSpPr/>
            <p:nvPr/>
          </p:nvGrpSpPr>
          <p:grpSpPr>
            <a:xfrm>
              <a:off x="4414680" y="488160"/>
              <a:ext cx="409680" cy="4157640"/>
              <a:chOff x="4414680" y="488160"/>
              <a:chExt cx="409680" cy="4157640"/>
            </a:xfrm>
          </p:grpSpPr>
          <p:sp>
            <p:nvSpPr>
              <p:cNvPr id="54" name="TextBox 6"/>
              <p:cNvSpPr/>
              <p:nvPr/>
            </p:nvSpPr>
            <p:spPr>
              <a:xfrm>
                <a:off x="4414680" y="436932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7"/>
              <p:cNvSpPr/>
              <p:nvPr/>
            </p:nvSpPr>
            <p:spPr>
              <a:xfrm>
                <a:off x="4414680" y="339912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8"/>
              <p:cNvSpPr/>
              <p:nvPr/>
            </p:nvSpPr>
            <p:spPr>
              <a:xfrm>
                <a:off x="4414680" y="242856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9"/>
              <p:cNvSpPr/>
              <p:nvPr/>
            </p:nvSpPr>
            <p:spPr>
              <a:xfrm>
                <a:off x="4414680" y="145836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Box 10"/>
              <p:cNvSpPr/>
              <p:nvPr/>
            </p:nvSpPr>
            <p:spPr>
              <a:xfrm>
                <a:off x="4414680" y="488160"/>
                <a:ext cx="4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1" lang="de-DE" sz="12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9" name="Group 40"/>
            <p:cNvGrpSpPr/>
            <p:nvPr/>
          </p:nvGrpSpPr>
          <p:grpSpPr>
            <a:xfrm>
              <a:off x="5290920" y="1700280"/>
              <a:ext cx="2632320" cy="2490480"/>
              <a:chOff x="5290920" y="1700280"/>
              <a:chExt cx="2632320" cy="2490480"/>
            </a:xfrm>
          </p:grpSpPr>
          <p:grpSp>
            <p:nvGrpSpPr>
              <p:cNvPr id="60" name="Group 51"/>
              <p:cNvGrpSpPr/>
              <p:nvPr/>
            </p:nvGrpSpPr>
            <p:grpSpPr>
              <a:xfrm>
                <a:off x="5290920" y="1700280"/>
                <a:ext cx="2585160" cy="977760"/>
                <a:chOff x="5290920" y="1700280"/>
                <a:chExt cx="2585160" cy="977760"/>
              </a:xfrm>
            </p:grpSpPr>
            <p:grpSp>
              <p:nvGrpSpPr>
                <p:cNvPr id="61" name="Group 90"/>
                <p:cNvGrpSpPr/>
                <p:nvPr/>
              </p:nvGrpSpPr>
              <p:grpSpPr>
                <a:xfrm>
                  <a:off x="7411680" y="2526120"/>
                  <a:ext cx="464400" cy="60840"/>
                  <a:chOff x="7411680" y="2526120"/>
                  <a:chExt cx="464400" cy="60840"/>
                </a:xfrm>
              </p:grpSpPr>
              <p:sp>
                <p:nvSpPr>
                  <p:cNvPr id="62" name="Straight Connector 30"/>
                  <p:cNvSpPr/>
                  <p:nvPr/>
                </p:nvSpPr>
                <p:spPr>
                  <a:xfrm>
                    <a:off x="7411680" y="2551680"/>
                    <a:ext cx="464400" cy="75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240" bIns="-39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Rectangle 31"/>
                  <p:cNvSpPr/>
                  <p:nvPr/>
                </p:nvSpPr>
                <p:spPr>
                  <a:xfrm>
                    <a:off x="7617600" y="2526120"/>
                    <a:ext cx="75600" cy="60840"/>
                  </a:xfrm>
                  <a:prstGeom prst="rect">
                    <a:avLst/>
                  </a:prstGeom>
                  <a:solidFill>
                    <a:srgbClr val="000000"/>
                  </a:solidFill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040" bIns="1404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4" name="Group 89"/>
                <p:cNvGrpSpPr/>
                <p:nvPr/>
              </p:nvGrpSpPr>
              <p:grpSpPr>
                <a:xfrm>
                  <a:off x="7386480" y="2279880"/>
                  <a:ext cx="465840" cy="91080"/>
                  <a:chOff x="7386480" y="2279880"/>
                  <a:chExt cx="465840" cy="91080"/>
                </a:xfrm>
              </p:grpSpPr>
              <p:sp>
                <p:nvSpPr>
                  <p:cNvPr id="65" name="Straight Connector 17"/>
                  <p:cNvSpPr/>
                  <p:nvPr/>
                </p:nvSpPr>
                <p:spPr>
                  <a:xfrm>
                    <a:off x="7386480" y="2329560"/>
                    <a:ext cx="465840" cy="6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0680" bIns="-40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Isosceles Triangle 18"/>
                  <p:cNvSpPr/>
                  <p:nvPr/>
                </p:nvSpPr>
                <p:spPr>
                  <a:xfrm>
                    <a:off x="7602840" y="2279880"/>
                    <a:ext cx="82440" cy="91080"/>
                  </a:xfrm>
                  <a:prstGeom prst="triangle">
                    <a:avLst>
                      <a:gd name="adj" fmla="val 50000"/>
                    </a:avLst>
                  </a:prstGeom>
                  <a:solidFill>
                    <a:srgbClr val="000000"/>
                  </a:solidFill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560" bIns="-1656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7" name="Group 100"/>
                <p:cNvGrpSpPr/>
                <p:nvPr/>
              </p:nvGrpSpPr>
              <p:grpSpPr>
                <a:xfrm>
                  <a:off x="7431480" y="2031840"/>
                  <a:ext cx="426960" cy="91800"/>
                  <a:chOff x="7431480" y="2031840"/>
                  <a:chExt cx="426960" cy="91800"/>
                </a:xfrm>
              </p:grpSpPr>
              <p:sp>
                <p:nvSpPr>
                  <p:cNvPr id="68" name="Diamond 26"/>
                  <p:cNvSpPr/>
                  <p:nvPr/>
                </p:nvSpPr>
                <p:spPr>
                  <a:xfrm>
                    <a:off x="7575840" y="2031840"/>
                    <a:ext cx="117360" cy="91800"/>
                  </a:xfrm>
                  <a:prstGeom prst="diamond">
                    <a:avLst/>
                  </a:prstGeom>
                  <a:solidFill>
                    <a:srgbClr val="000000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" bIns="-72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Straight Connector 27"/>
                  <p:cNvSpPr/>
                  <p:nvPr/>
                </p:nvSpPr>
                <p:spPr>
                  <a:xfrm>
                    <a:off x="7431480" y="2084040"/>
                    <a:ext cx="426960" cy="46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2120" bIns="-421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0" name="Rectangle 57"/>
                <p:cNvSpPr/>
                <p:nvPr/>
              </p:nvSpPr>
              <p:spPr>
                <a:xfrm>
                  <a:off x="5313960" y="1959840"/>
                  <a:ext cx="1441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ntinuous Light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58"/>
                <p:cNvSpPr/>
                <p:nvPr/>
              </p:nvSpPr>
              <p:spPr>
                <a:xfrm>
                  <a:off x="5290920" y="1700280"/>
                  <a:ext cx="16452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otal Cell Counts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59"/>
                <p:cNvSpPr/>
                <p:nvPr/>
              </p:nvSpPr>
              <p:spPr>
                <a:xfrm>
                  <a:off x="5310720" y="2187000"/>
                  <a:ext cx="1409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ntinuous Dark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Rectangle 60"/>
                <p:cNvSpPr/>
                <p:nvPr/>
              </p:nvSpPr>
              <p:spPr>
                <a:xfrm>
                  <a:off x="5334480" y="2401560"/>
                  <a:ext cx="9352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Light/Dark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" name="Group 81"/>
              <p:cNvGrpSpPr/>
              <p:nvPr/>
            </p:nvGrpSpPr>
            <p:grpSpPr>
              <a:xfrm>
                <a:off x="5295600" y="3213000"/>
                <a:ext cx="2627640" cy="977760"/>
                <a:chOff x="5295600" y="3213000"/>
                <a:chExt cx="2627640" cy="977760"/>
              </a:xfrm>
            </p:grpSpPr>
            <p:sp>
              <p:nvSpPr>
                <p:cNvPr id="75" name="Rectangle 43"/>
                <p:cNvSpPr/>
                <p:nvPr/>
              </p:nvSpPr>
              <p:spPr>
                <a:xfrm>
                  <a:off x="5295600" y="3213000"/>
                  <a:ext cx="13680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Viable Counts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6" name="Group 80"/>
                <p:cNvGrpSpPr/>
                <p:nvPr/>
              </p:nvGrpSpPr>
              <p:grpSpPr>
                <a:xfrm>
                  <a:off x="5310720" y="3472560"/>
                  <a:ext cx="2612520" cy="718200"/>
                  <a:chOff x="5310720" y="3472560"/>
                  <a:chExt cx="2612520" cy="718200"/>
                </a:xfrm>
              </p:grpSpPr>
              <p:sp>
                <p:nvSpPr>
                  <p:cNvPr id="77" name="Straight Connector 10"/>
                  <p:cNvSpPr/>
                  <p:nvPr/>
                </p:nvSpPr>
                <p:spPr>
                  <a:xfrm>
                    <a:off x="7453440" y="4046760"/>
                    <a:ext cx="469800" cy="46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2120" bIns="-421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Straight Connector 11"/>
                  <p:cNvSpPr/>
                  <p:nvPr/>
                </p:nvSpPr>
                <p:spPr>
                  <a:xfrm>
                    <a:off x="7452000" y="3830760"/>
                    <a:ext cx="469800" cy="46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2120" bIns="-421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Straight Connector 12"/>
                  <p:cNvSpPr/>
                  <p:nvPr/>
                </p:nvSpPr>
                <p:spPr>
                  <a:xfrm>
                    <a:off x="7432920" y="3565440"/>
                    <a:ext cx="465120" cy="61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0680" bIns="-40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Rectangle 48"/>
                  <p:cNvSpPr/>
                  <p:nvPr/>
                </p:nvSpPr>
                <p:spPr>
                  <a:xfrm>
                    <a:off x="5313960" y="3472560"/>
                    <a:ext cx="14410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de-DE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ontinuous Light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Rectangle 49"/>
                  <p:cNvSpPr/>
                  <p:nvPr/>
                </p:nvSpPr>
                <p:spPr>
                  <a:xfrm>
                    <a:off x="5310720" y="3699720"/>
                    <a:ext cx="14090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de-DE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ontinuous Dark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Rectangle 50"/>
                  <p:cNvSpPr/>
                  <p:nvPr/>
                </p:nvSpPr>
                <p:spPr>
                  <a:xfrm>
                    <a:off x="5325480" y="3914280"/>
                    <a:ext cx="9352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de-DE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Light/Dark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Isosceles Triangle 16"/>
                  <p:cNvSpPr/>
                  <p:nvPr/>
                </p:nvSpPr>
                <p:spPr>
                  <a:xfrm>
                    <a:off x="7639200" y="3770280"/>
                    <a:ext cx="82440" cy="90360"/>
                  </a:xfrm>
                  <a:prstGeom prst="triangle">
                    <a:avLst>
                      <a:gd name="adj" fmla="val 50000"/>
                    </a:avLst>
                  </a:prstGeom>
                  <a:solidFill>
                    <a:srgbClr val="000000"/>
                  </a:solidFill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560" bIns="-1656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Rectangle 17"/>
                  <p:cNvSpPr/>
                  <p:nvPr/>
                </p:nvSpPr>
                <p:spPr>
                  <a:xfrm>
                    <a:off x="7653600" y="4016520"/>
                    <a:ext cx="77760" cy="60120"/>
                  </a:xfrm>
                  <a:prstGeom prst="rect">
                    <a:avLst/>
                  </a:prstGeom>
                  <a:solidFill>
                    <a:srgbClr val="000000"/>
                  </a:solidFill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3320" bIns="1332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" name="Diamond 18"/>
                  <p:cNvSpPr/>
                  <p:nvPr/>
                </p:nvSpPr>
                <p:spPr>
                  <a:xfrm>
                    <a:off x="7616880" y="3505320"/>
                    <a:ext cx="118800" cy="99720"/>
                  </a:xfrm>
                  <a:prstGeom prst="diamond">
                    <a:avLst/>
                  </a:prstGeom>
                  <a:solidFill>
                    <a:srgbClr val="000000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" bIns="324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sp>
        <p:nvSpPr>
          <p:cNvPr id="86" name="Rectangle 47"/>
          <p:cNvSpPr/>
          <p:nvPr/>
        </p:nvSpPr>
        <p:spPr>
          <a:xfrm>
            <a:off x="611280" y="5232240"/>
            <a:ext cx="7632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2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anges in total and viable count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. shibae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uring starvation in complex medium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ymbols: total (solid lines) and viable (broken lines) counts of cells starved under light/dark cycles (LD, 12/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12 h, squares, 53 µmol photons 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−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−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tinuous light (diamonds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26 µmol photons 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−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−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or in the dark (triangles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ll showed highes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urvival rates under DD condi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7T13:38:57Z</dcterms:created>
  <dc:creator>ICBM</dc:creator>
  <dc:description/>
  <dc:language>en-US</dc:language>
  <cp:lastModifiedBy>ICBM</cp:lastModifiedBy>
  <dcterms:modified xsi:type="dcterms:W3CDTF">2013-11-22T11:11:33Z</dcterms:modified>
  <cp:revision>4</cp:revision>
  <dc:subject/>
  <dc:title>Slide 1</dc:title>
</cp:coreProperties>
</file>